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1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9144000" cy="5143500" type="screen16x9"/>
  <p:notesSz cx="6858000" cy="9144000"/>
  <p:embeddedFontLst>
    <p:embeddedFont>
      <p:font typeface="Lato" panose="020F0502020204030203" pitchFamily="34" charset="0"/>
      <p:regular r:id="rId14"/>
      <p:bold r:id="rId15"/>
      <p:italic r:id="rId16"/>
      <p:boldItalic r:id="rId17"/>
    </p:embeddedFont>
    <p:embeddedFont>
      <p:font typeface="Raleway" pitchFamily="2" charset="77"/>
      <p:regular r:id="rId18"/>
      <p:bold r:id="rId19"/>
      <p:italic r:id="rId20"/>
      <p:boldItalic r:id="rId2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5753"/>
  </p:normalViewPr>
  <p:slideViewPr>
    <p:cSldViewPr snapToGrid="0">
      <p:cViewPr varScale="1">
        <p:scale>
          <a:sx n="139" d="100"/>
          <a:sy n="139" d="100"/>
        </p:scale>
        <p:origin x="176" y="54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3" d="100"/>
          <a:sy n="83" d="100"/>
        </p:scale>
        <p:origin x="3992" y="2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font" Target="fonts/font5.fntdata"/><Relationship Id="rId3" Type="http://schemas.openxmlformats.org/officeDocument/2006/relationships/slide" Target="slides/slide2.xml"/><Relationship Id="rId21" Type="http://schemas.openxmlformats.org/officeDocument/2006/relationships/font" Target="fonts/font8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4.fntdata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font" Target="fonts/font3.fntdata"/><Relationship Id="rId20" Type="http://schemas.openxmlformats.org/officeDocument/2006/relationships/font" Target="fonts/font7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font" Target="fonts/font2.fntdata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6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1.fntdata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Radiocephalic_fistula.svg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Vascular_closure_device.jpg" TargetMode="External"/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70" name="Google Shape;70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g3b9612f94a7_0_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34" name="Google Shape;134;g3b9612f94a7_0_2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neurysm, pseudoaneurysm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Signs of infection--cover broadly with Methicillin-resistant Staphylococcus aureus ((MRSA) and gram-negative coverag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Ulceration 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hinned ski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Only hemorrhage control is a tourniquet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Recurrent bleeding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Loss of a palpable thrill at fistula site after pressure is applied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g3b9612f94a7_2_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40" name="Google Shape;140;g3b9612f94a7_2_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3b9612f94a7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76" name="Google Shape;76;g3b9612f94a7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Fistula--connection between artery and vein without exogenous materia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Graft--donor vein to create connection or synthetic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source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Radiocephalic Fistula. In: Wikimedia Commons. 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  <a:hlinkClick r:id="rId3"/>
              </a:rPr>
              <a:t>https://commons.wikimedia.org/wiki/File:Radiocephalic_fistula.svg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. Published July 28, 2008. Accessed January 20, 2026. CC BY-SA 3.0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g3b9612f94a7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87" name="Google Shape;87;g3b9612f94a7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ypes of emergencies: hyperkalemia, volume overload, bleeding fistula/graft, infection, aneurysm, pseudoaneurysm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neurysm--dilation of all 3 layers of vessel wall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Pseudoaneurysm--extramural pulsatile hematoma with blood flow walled off in the soft tissu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Bleeding emergency: increased risk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pproximately 250 deaths per year 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Grafts have a greater risk than fistulas for complications including bleeding, ~ 6x relative risk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Worse with: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Coagulopathy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ncreased intraluminal pressure from proximal vein stenosis (creates outflow obstruction, causes increased intraluminal pressure, increases risk of bleeding)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nfection at the sit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Hypertension 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Repeat trauma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3b9612f94a7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93" name="Google Shape;93;g3b9612f94a7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3b9612f94a7_0_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99" name="Google Shape;99;g3b9612f94a7_0_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Direct Pressur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Establish IV access, in case treatment for hemorrhagic shock is needed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pply pressure with 1 finger or a fistula clamp (broad pressure/bulky dressing is too diffuse and allows for continued bleeding)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dditionally want to maintain the underlying thrill so as not to cause thrombosi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pply pressure for 10-20 mi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f hemostasis achieved, check for palpable thrill, if no longer present, consult a vascular surgeo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g3b9612f94a7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05" name="Google Shape;105;g3b9612f94a7_1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opical hemostatic agents: gelatin sponges, microfibrillar collagen, oxidized regenerated cellulose, tranexamic acid solution–soaked gauze, topical thrombin either on gauze or on prothrombotic matrix, and chitosa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Gelfoam--water insoluble sponge from porcine skin, Gelatin granules, and water, creates a mechanical matrix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pply bandage once hemostasis is achieved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Chitosan--complex 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carbohydrate derived from Chiti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hrombin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 Activates XI, VIII, V, XII and I to facilitate hemostasi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1200"/>
              </a:spcBef>
              <a:spcAft>
                <a:spcPts val="120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3b9612f94a7_0_35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11" name="Google Shape;111;g3b9612f94a7_0_35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Needle type- taper, NO cutting needle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aper needle--round, designed to separate fibers rather than cut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Cutting--cutting edge on inside of circl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Reverse cutting--cutting edge on outside of circl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3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mage 12: Needle Types: Author’s own image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source: 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uthor’s own image</a:t>
            </a:r>
            <a:r>
              <a:rPr lang="en-US" dirty="0">
                <a:effectLst/>
              </a:rPr>
              <a:t> </a:t>
            </a: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g3b9612f94a7_0_3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17" name="Google Shape;117;g3b9612f94a7_0_33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Figure 8 sutur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Horizontal mattress or purse string sutur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Vascular closure butt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Goal: Tie only as much as you need to be effective without causing skin necrosi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endParaRPr lang="en-US" sz="110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Tourniquet--avoid unless bleeding is truly uncontrolled because it can lead to complications including thrombosis and possible need for new dialysis access;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f successfully able to control bleeding, observe for 1-2 hours afterward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sources: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uthor’s own image</a:t>
            </a:r>
            <a:r>
              <a:rPr lang="en-US" dirty="0">
                <a:effectLst/>
              </a:rPr>
              <a:t>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Purse String Suture. In: Wikimedia Commons. https://</a:t>
            </a:r>
            <a:r>
              <a:rPr lang="en-US" sz="1100" b="0" i="0" u="none" strike="noStrike" cap="none" dirty="0" err="1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commons.wikimedia.org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/wiki/</a:t>
            </a:r>
            <a:r>
              <a:rPr lang="en-US" sz="1100" b="0" i="0" u="none" strike="noStrike" cap="none" dirty="0" err="1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File:Purse_string_suture.svg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 Published February 28, 2014. Accessed January 20, 2026. CC BY-SA 3.0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Vascular Closure Device. In: Wikimedia Commons. 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  <a:hlinkClick r:id="rId3"/>
              </a:rPr>
              <a:t>https://commons.wikimedia.org/wiki/File:Vascular_closure_device.jpg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 Published May 6, 2023. Accessed January 20, 2026. CC BY-SA 4.0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g3b9612f94a7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  <p:txBody>
          <a:bodyPr/>
          <a:lstStyle/>
          <a:p>
            <a:endParaRPr lang="en-US"/>
          </a:p>
        </p:txBody>
      </p:sp>
      <p:sp>
        <p:nvSpPr>
          <p:cNvPr id="128" name="Google Shape;128;g3b9612f94a7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Anticoagulant reversal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Prothrombin complex concentrate (PCC) for Factor Xa inhibitors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Vitamin K &amp; PCC for warfari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2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darucizumab for dabigatran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Desmopressin (DDAVP) 0.3 ug/kg for bleeding in the setting of uremia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lvl="1"/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Protamine--consider use of protamine if heparin is used during dialysis: 1 mg for every 100 mg heparin, 10-20 mg total</a:t>
            </a:r>
            <a:endParaRPr lang="en-US" sz="1050" b="0" i="0" u="none" strike="noStrike" cap="none" dirty="0">
              <a:solidFill>
                <a:srgbClr val="000000"/>
              </a:solidFill>
              <a:effectLst/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bg>
      <p:bgPr>
        <a:solidFill>
          <a:schemeClr val="dk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Google Shape;10;p2"/>
          <p:cNvCxnSpPr/>
          <p:nvPr/>
        </p:nvCxnSpPr>
        <p:spPr>
          <a:xfrm>
            <a:off x="2477724" y="415650"/>
            <a:ext cx="624420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1" name="Google Shape;11;p2"/>
          <p:cNvCxnSpPr/>
          <p:nvPr/>
        </p:nvCxnSpPr>
        <p:spPr>
          <a:xfrm>
            <a:off x="2477724" y="4740000"/>
            <a:ext cx="6244200" cy="0"/>
          </a:xfrm>
          <a:prstGeom prst="straightConnector1">
            <a:avLst/>
          </a:prstGeom>
          <a:noFill/>
          <a:ln w="1905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2" name="Google Shape;12;p2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3" name="Google Shape;13;p2"/>
          <p:cNvSpPr txBox="1">
            <a:spLocks noGrp="1"/>
          </p:cNvSpPr>
          <p:nvPr>
            <p:ph type="ctrTitle"/>
          </p:nvPr>
        </p:nvSpPr>
        <p:spPr>
          <a:xfrm>
            <a:off x="2371725" y="630225"/>
            <a:ext cx="6331500" cy="1542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ubTitle" idx="1"/>
          </p:nvPr>
        </p:nvSpPr>
        <p:spPr>
          <a:xfrm>
            <a:off x="2390267" y="3238450"/>
            <a:ext cx="6331500" cy="1241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>
                <a:solidFill>
                  <a:schemeClr val="lt1"/>
                </a:solidFill>
              </a:defRPr>
            </a:lvl1pPr>
            <a:lvl2pPr lv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2pPr>
            <a:lvl3pPr lvl="2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3pPr>
            <a:lvl4pPr lvl="3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4pPr>
            <a:lvl5pPr lvl="4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5pPr>
            <a:lvl6pPr lvl="5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6pPr>
            <a:lvl7pPr lvl="6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7pPr>
            <a:lvl8pPr lvl="7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8pPr>
            <a:lvl9pPr lvl="8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None/>
              <a:defRPr sz="18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5" name="Google Shape;15;p2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>
                <a:solidFill>
                  <a:schemeClr val="lt1"/>
                </a:solidFill>
              </a:defRPr>
            </a:lvl1pPr>
            <a:lvl2pPr lvl="1">
              <a:buNone/>
              <a:defRPr>
                <a:solidFill>
                  <a:schemeClr val="lt1"/>
                </a:solidFill>
              </a:defRPr>
            </a:lvl2pPr>
            <a:lvl3pPr lvl="2">
              <a:buNone/>
              <a:defRPr>
                <a:solidFill>
                  <a:schemeClr val="lt1"/>
                </a:solidFill>
              </a:defRPr>
            </a:lvl3pPr>
            <a:lvl4pPr lvl="3">
              <a:buNone/>
              <a:defRPr>
                <a:solidFill>
                  <a:schemeClr val="lt1"/>
                </a:solidFill>
              </a:defRPr>
            </a:lvl4pPr>
            <a:lvl5pPr lvl="4">
              <a:buNone/>
              <a:defRPr>
                <a:solidFill>
                  <a:schemeClr val="lt1"/>
                </a:solidFill>
              </a:defRPr>
            </a:lvl5pPr>
            <a:lvl6pPr lvl="5">
              <a:buNone/>
              <a:defRPr>
                <a:solidFill>
                  <a:schemeClr val="lt1"/>
                </a:solidFill>
              </a:defRPr>
            </a:lvl6pPr>
            <a:lvl7pPr lvl="6">
              <a:buNone/>
              <a:defRPr>
                <a:solidFill>
                  <a:schemeClr val="lt1"/>
                </a:solidFill>
              </a:defRPr>
            </a:lvl7pPr>
            <a:lvl8pPr lvl="7">
              <a:buNone/>
              <a:defRPr>
                <a:solidFill>
                  <a:schemeClr val="lt1"/>
                </a:solidFill>
              </a:defRPr>
            </a:lvl8pPr>
            <a:lvl9pPr lvl="8">
              <a:buNone/>
              <a:defRPr>
                <a:solidFill>
                  <a:schemeClr val="lt1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1" name="Google Shape;61;p11"/>
          <p:cNvCxnSpPr/>
          <p:nvPr/>
        </p:nvCxnSpPr>
        <p:spPr>
          <a:xfrm>
            <a:off x="425200" y="4740000"/>
            <a:ext cx="82968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62" name="Google Shape;62;p11"/>
          <p:cNvCxnSpPr/>
          <p:nvPr/>
        </p:nvCxnSpPr>
        <p:spPr>
          <a:xfrm>
            <a:off x="425200" y="415650"/>
            <a:ext cx="8296800" cy="0"/>
          </a:xfrm>
          <a:prstGeom prst="straightConnector1">
            <a:avLst/>
          </a:prstGeom>
          <a:noFill/>
          <a:ln w="3810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63" name="Google Shape;63;p11"/>
          <p:cNvSpPr txBox="1">
            <a:spLocks noGrp="1"/>
          </p:cNvSpPr>
          <p:nvPr>
            <p:ph type="title" hasCustomPrompt="1"/>
          </p:nvPr>
        </p:nvSpPr>
        <p:spPr>
          <a:xfrm>
            <a:off x="853950" y="1304850"/>
            <a:ext cx="7436100" cy="15384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1pPr>
            <a:lvl2pPr lvl="1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2pPr>
            <a:lvl3pPr lvl="2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3pPr>
            <a:lvl4pPr lvl="3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4pPr>
            <a:lvl5pPr lvl="4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5pPr>
            <a:lvl6pPr lvl="5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6pPr>
            <a:lvl7pPr lvl="6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7pPr>
            <a:lvl8pPr lvl="7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8pPr>
            <a:lvl9pPr lvl="8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600"/>
              <a:buFont typeface="Lato"/>
              <a:buNone/>
              <a:defRPr sz="96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r>
              <a:t>xx%</a:t>
            </a:r>
          </a:p>
        </p:txBody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53950" y="2919450"/>
            <a:ext cx="7436100" cy="1071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bg>
      <p:bgPr>
        <a:solidFill>
          <a:schemeClr val="dk1"/>
        </a:solidFill>
        <a:effectLst/>
      </p:bgPr>
    </p:bg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Google Shape;17;p3"/>
          <p:cNvCxnSpPr/>
          <p:nvPr/>
        </p:nvCxnSpPr>
        <p:spPr>
          <a:xfrm>
            <a:off x="425200" y="415650"/>
            <a:ext cx="8296800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8" name="Google Shape;18;p3"/>
          <p:cNvCxnSpPr/>
          <p:nvPr/>
        </p:nvCxnSpPr>
        <p:spPr>
          <a:xfrm>
            <a:off x="425200" y="4740000"/>
            <a:ext cx="8296800" cy="0"/>
          </a:xfrm>
          <a:prstGeom prst="straightConnector1">
            <a:avLst/>
          </a:prstGeom>
          <a:noFill/>
          <a:ln w="1905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9" name="Google Shape;19;p3"/>
          <p:cNvSpPr txBox="1">
            <a:spLocks noGrp="1"/>
          </p:cNvSpPr>
          <p:nvPr>
            <p:ph type="title"/>
          </p:nvPr>
        </p:nvSpPr>
        <p:spPr>
          <a:xfrm>
            <a:off x="406425" y="1806825"/>
            <a:ext cx="8296800" cy="1542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1pPr>
            <a:lvl2pPr lvl="1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2pPr>
            <a:lvl3pPr lvl="2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3pPr>
            <a:lvl4pPr lvl="3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4pPr>
            <a:lvl5pPr lvl="4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5pPr>
            <a:lvl6pPr lvl="5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6pPr>
            <a:lvl7pPr lvl="6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7pPr>
            <a:lvl8pPr lvl="7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8pPr>
            <a:lvl9pPr lvl="8" algn="ctr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>
                <a:solidFill>
                  <a:schemeClr val="lt1"/>
                </a:solidFill>
              </a:defRPr>
            </a:lvl1pPr>
            <a:lvl2pPr lvl="1">
              <a:buNone/>
              <a:defRPr>
                <a:solidFill>
                  <a:schemeClr val="lt1"/>
                </a:solidFill>
              </a:defRPr>
            </a:lvl2pPr>
            <a:lvl3pPr lvl="2">
              <a:buNone/>
              <a:defRPr>
                <a:solidFill>
                  <a:schemeClr val="lt1"/>
                </a:solidFill>
              </a:defRPr>
            </a:lvl3pPr>
            <a:lvl4pPr lvl="3">
              <a:buNone/>
              <a:defRPr>
                <a:solidFill>
                  <a:schemeClr val="lt1"/>
                </a:solidFill>
              </a:defRPr>
            </a:lvl4pPr>
            <a:lvl5pPr lvl="4">
              <a:buNone/>
              <a:defRPr>
                <a:solidFill>
                  <a:schemeClr val="lt1"/>
                </a:solidFill>
              </a:defRPr>
            </a:lvl5pPr>
            <a:lvl6pPr lvl="5">
              <a:buNone/>
              <a:defRPr>
                <a:solidFill>
                  <a:schemeClr val="lt1"/>
                </a:solidFill>
              </a:defRPr>
            </a:lvl6pPr>
            <a:lvl7pPr lvl="6">
              <a:buNone/>
              <a:defRPr>
                <a:solidFill>
                  <a:schemeClr val="lt1"/>
                </a:solidFill>
              </a:defRPr>
            </a:lvl7pPr>
            <a:lvl8pPr lvl="7">
              <a:buNone/>
              <a:defRPr>
                <a:solidFill>
                  <a:schemeClr val="lt1"/>
                </a:solidFill>
              </a:defRPr>
            </a:lvl8pPr>
            <a:lvl9pPr lvl="8">
              <a:buNone/>
              <a:defRPr>
                <a:solidFill>
                  <a:schemeClr val="lt1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" name="Google Shape;22;p4"/>
          <p:cNvCxnSpPr/>
          <p:nvPr/>
        </p:nvCxnSpPr>
        <p:spPr>
          <a:xfrm>
            <a:off x="2477724" y="415650"/>
            <a:ext cx="6244200" cy="0"/>
          </a:xfrm>
          <a:prstGeom prst="straightConnector1">
            <a:avLst/>
          </a:prstGeom>
          <a:noFill/>
          <a:ln w="3810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3" name="Google Shape;23;p4"/>
          <p:cNvCxnSpPr/>
          <p:nvPr/>
        </p:nvCxnSpPr>
        <p:spPr>
          <a:xfrm>
            <a:off x="2477724" y="4740000"/>
            <a:ext cx="62442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4" name="Google Shape;24;p4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25" name="Google Shape;25;p4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" name="Google Shape;29;p5"/>
          <p:cNvCxnSpPr/>
          <p:nvPr/>
        </p:nvCxnSpPr>
        <p:spPr>
          <a:xfrm>
            <a:off x="2477724" y="415650"/>
            <a:ext cx="6244200" cy="0"/>
          </a:xfrm>
          <a:prstGeom prst="straightConnector1">
            <a:avLst/>
          </a:prstGeom>
          <a:noFill/>
          <a:ln w="3810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30" name="Google Shape;30;p5"/>
          <p:cNvCxnSpPr/>
          <p:nvPr/>
        </p:nvCxnSpPr>
        <p:spPr>
          <a:xfrm>
            <a:off x="2477724" y="4740000"/>
            <a:ext cx="62442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31" name="Google Shape;31;p5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2" name="Google Shape;32;p5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body" idx="1"/>
          </p:nvPr>
        </p:nvSpPr>
        <p:spPr>
          <a:xfrm>
            <a:off x="2400303" y="1602675"/>
            <a:ext cx="30714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body" idx="2"/>
          </p:nvPr>
        </p:nvSpPr>
        <p:spPr>
          <a:xfrm>
            <a:off x="5650572" y="1602675"/>
            <a:ext cx="30714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6"/>
          <p:cNvSpPr txBox="1">
            <a:spLocks noGrp="1"/>
          </p:cNvSpPr>
          <p:nvPr>
            <p:ph type="title"/>
          </p:nvPr>
        </p:nvSpPr>
        <p:spPr>
          <a:xfrm>
            <a:off x="303300" y="411575"/>
            <a:ext cx="8520600" cy="639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0" name="Google Shape;40;p7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319500" y="936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319500" y="1846804"/>
            <a:ext cx="2808000" cy="2806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bg>
      <p:bgPr>
        <a:solidFill>
          <a:schemeClr val="lt2"/>
        </a:solidFill>
        <a:effectLst/>
      </p:bgPr>
    </p:bg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Google Shape;45;p8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283103" y="712141"/>
            <a:ext cx="6244200" cy="38355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None/>
              <a:defRPr sz="48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>
                <a:solidFill>
                  <a:schemeClr val="lt1"/>
                </a:solidFill>
              </a:defRPr>
            </a:lvl1pPr>
            <a:lvl2pPr lvl="1">
              <a:buNone/>
              <a:defRPr>
                <a:solidFill>
                  <a:schemeClr val="lt1"/>
                </a:solidFill>
              </a:defRPr>
            </a:lvl2pPr>
            <a:lvl3pPr lvl="2">
              <a:buNone/>
              <a:defRPr>
                <a:solidFill>
                  <a:schemeClr val="lt1"/>
                </a:solidFill>
              </a:defRPr>
            </a:lvl3pPr>
            <a:lvl4pPr lvl="3">
              <a:buNone/>
              <a:defRPr>
                <a:solidFill>
                  <a:schemeClr val="lt1"/>
                </a:solidFill>
              </a:defRPr>
            </a:lvl4pPr>
            <a:lvl5pPr lvl="4">
              <a:buNone/>
              <a:defRPr>
                <a:solidFill>
                  <a:schemeClr val="lt1"/>
                </a:solidFill>
              </a:defRPr>
            </a:lvl5pPr>
            <a:lvl6pPr lvl="5">
              <a:buNone/>
              <a:defRPr>
                <a:solidFill>
                  <a:schemeClr val="lt1"/>
                </a:solidFill>
              </a:defRPr>
            </a:lvl6pPr>
            <a:lvl7pPr lvl="6">
              <a:buNone/>
              <a:defRPr>
                <a:solidFill>
                  <a:schemeClr val="lt1"/>
                </a:solidFill>
              </a:defRPr>
            </a:lvl7pPr>
            <a:lvl8pPr lvl="7">
              <a:buNone/>
              <a:defRPr>
                <a:solidFill>
                  <a:schemeClr val="lt1"/>
                </a:solidFill>
              </a:defRPr>
            </a:lvl8pPr>
            <a:lvl9pPr lvl="8">
              <a:buNone/>
              <a:defRPr>
                <a:solidFill>
                  <a:schemeClr val="lt1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9"/>
          <p:cNvSpPr/>
          <p:nvPr/>
        </p:nvSpPr>
        <p:spPr>
          <a:xfrm>
            <a:off x="4572000" y="125"/>
            <a:ext cx="4572000" cy="5143500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50" name="Google Shape;50;p9"/>
          <p:cNvCxnSpPr/>
          <p:nvPr/>
        </p:nvCxnSpPr>
        <p:spPr>
          <a:xfrm>
            <a:off x="5029675" y="4495500"/>
            <a:ext cx="468300" cy="0"/>
          </a:xfrm>
          <a:prstGeom prst="straightConnector1">
            <a:avLst/>
          </a:prstGeom>
          <a:noFill/>
          <a:ln w="19050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51" name="Google Shape;51;p9"/>
          <p:cNvSpPr txBox="1">
            <a:spLocks noGrp="1"/>
          </p:cNvSpPr>
          <p:nvPr>
            <p:ph type="title"/>
          </p:nvPr>
        </p:nvSpPr>
        <p:spPr>
          <a:xfrm>
            <a:off x="265500" y="1397350"/>
            <a:ext cx="4045200" cy="1318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1pPr>
            <a:lvl2pPr lvl="1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2pPr>
            <a:lvl3pPr lvl="2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3pPr>
            <a:lvl4pPr lvl="3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4pPr>
            <a:lvl5pPr lvl="4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5pPr>
            <a:lvl6pPr lvl="5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6pPr>
            <a:lvl7pPr lvl="6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7pPr>
            <a:lvl8pPr lvl="7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8pPr>
            <a:lvl9pPr lvl="8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  <a:defRPr sz="3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subTitle" idx="1"/>
          </p:nvPr>
        </p:nvSpPr>
        <p:spPr>
          <a:xfrm>
            <a:off x="265500" y="2735371"/>
            <a:ext cx="4045200" cy="1345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body" idx="2"/>
          </p:nvPr>
        </p:nvSpPr>
        <p:spPr>
          <a:xfrm>
            <a:off x="4939500" y="724200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  <a:defRPr>
                <a:solidFill>
                  <a:schemeClr val="lt1"/>
                </a:solidFill>
              </a:defRPr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54" name="Google Shape;54;p9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>
                <a:solidFill>
                  <a:schemeClr val="lt1"/>
                </a:solidFill>
              </a:defRPr>
            </a:lvl1pPr>
            <a:lvl2pPr lvl="1">
              <a:buNone/>
              <a:defRPr>
                <a:solidFill>
                  <a:schemeClr val="lt1"/>
                </a:solidFill>
              </a:defRPr>
            </a:lvl2pPr>
            <a:lvl3pPr lvl="2">
              <a:buNone/>
              <a:defRPr>
                <a:solidFill>
                  <a:schemeClr val="lt1"/>
                </a:solidFill>
              </a:defRPr>
            </a:lvl3pPr>
            <a:lvl4pPr lvl="3">
              <a:buNone/>
              <a:defRPr>
                <a:solidFill>
                  <a:schemeClr val="lt1"/>
                </a:solidFill>
              </a:defRPr>
            </a:lvl4pPr>
            <a:lvl5pPr lvl="4">
              <a:buNone/>
              <a:defRPr>
                <a:solidFill>
                  <a:schemeClr val="lt1"/>
                </a:solidFill>
              </a:defRPr>
            </a:lvl5pPr>
            <a:lvl6pPr lvl="5">
              <a:buNone/>
              <a:defRPr>
                <a:solidFill>
                  <a:schemeClr val="lt1"/>
                </a:solidFill>
              </a:defRPr>
            </a:lvl6pPr>
            <a:lvl7pPr lvl="6">
              <a:buNone/>
              <a:defRPr>
                <a:solidFill>
                  <a:schemeClr val="lt1"/>
                </a:solidFill>
              </a:defRPr>
            </a:lvl7pPr>
            <a:lvl8pPr lvl="7">
              <a:buNone/>
              <a:defRPr>
                <a:solidFill>
                  <a:schemeClr val="lt1"/>
                </a:solidFill>
              </a:defRPr>
            </a:lvl8pPr>
            <a:lvl9pPr lvl="8">
              <a:buNone/>
              <a:defRPr>
                <a:solidFill>
                  <a:schemeClr val="lt1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6" name="Google Shape;56;p10"/>
          <p:cNvCxnSpPr/>
          <p:nvPr/>
        </p:nvCxnSpPr>
        <p:spPr>
          <a:xfrm>
            <a:off x="425200" y="4740000"/>
            <a:ext cx="82968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57" name="Google Shape;57;p10"/>
          <p:cNvCxnSpPr/>
          <p:nvPr/>
        </p:nvCxnSpPr>
        <p:spPr>
          <a:xfrm>
            <a:off x="425198" y="415650"/>
            <a:ext cx="183300" cy="0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58" name="Google Shape;58;p10"/>
          <p:cNvSpPr txBox="1">
            <a:spLocks noGrp="1"/>
          </p:cNvSpPr>
          <p:nvPr>
            <p:ph type="body" idx="1"/>
          </p:nvPr>
        </p:nvSpPr>
        <p:spPr>
          <a:xfrm>
            <a:off x="328017" y="4226025"/>
            <a:ext cx="83886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wiss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  <a:defRPr sz="3000" b="1">
                <a:solidFill>
                  <a:schemeClr val="dk2"/>
                </a:solidFill>
                <a:latin typeface="Raleway"/>
                <a:ea typeface="Raleway"/>
                <a:cs typeface="Raleway"/>
                <a:sym typeface="Raleway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Lato"/>
              <a:buChar char="●"/>
              <a:defRPr sz="18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○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■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●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○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■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●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○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Lato"/>
              <a:buChar char="■"/>
              <a:defRPr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1pPr>
            <a:lvl2pPr lvl="1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2pPr>
            <a:lvl3pPr lvl="2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3pPr>
            <a:lvl4pPr lvl="3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4pPr>
            <a:lvl5pPr lvl="4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5pPr>
            <a:lvl6pPr lvl="5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6pPr>
            <a:lvl7pPr lvl="6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7pPr>
            <a:lvl8pPr lvl="7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8pPr>
            <a:lvl9pPr lvl="8" algn="r">
              <a:buNone/>
              <a:defRPr sz="1000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3"/>
          <p:cNvSpPr txBox="1">
            <a:spLocks noGrp="1"/>
          </p:cNvSpPr>
          <p:nvPr>
            <p:ph type="ctrTitle"/>
          </p:nvPr>
        </p:nvSpPr>
        <p:spPr>
          <a:xfrm>
            <a:off x="2390275" y="853850"/>
            <a:ext cx="6331500" cy="1542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Dialysis Access Emergencies</a:t>
            </a:r>
            <a:endParaRPr dirty="0"/>
          </a:p>
        </p:txBody>
      </p:sp>
      <p:sp>
        <p:nvSpPr>
          <p:cNvPr id="73" name="Google Shape;73;p13"/>
          <p:cNvSpPr txBox="1">
            <a:spLocks noGrp="1"/>
          </p:cNvSpPr>
          <p:nvPr>
            <p:ph type="subTitle" idx="1"/>
          </p:nvPr>
        </p:nvSpPr>
        <p:spPr>
          <a:xfrm>
            <a:off x="2390267" y="3238450"/>
            <a:ext cx="6331500" cy="1241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ntent created by: Mary Jordan, MD</a:t>
            </a:r>
            <a:endParaRPr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E774F6-EC23-A603-20F0-08EF28F951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66736" y="4633058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22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When to consult a specialist?</a:t>
            </a:r>
            <a:endParaRPr/>
          </a:p>
        </p:txBody>
      </p:sp>
      <p:sp>
        <p:nvSpPr>
          <p:cNvPr id="137" name="Google Shape;137;p22"/>
          <p:cNvSpPr txBox="1">
            <a:spLocks noGrp="1"/>
          </p:cNvSpPr>
          <p:nvPr>
            <p:ph type="body" idx="1"/>
          </p:nvPr>
        </p:nvSpPr>
        <p:spPr>
          <a:xfrm>
            <a:off x="216800" y="1211350"/>
            <a:ext cx="8042100" cy="2631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2743200" marR="0" lvl="3" indent="-34290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Aneurysm, pseudoaneurysm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Signs of infection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Ulceration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Thinned skin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Only hemorrhage control is a tourniquet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Recurrent bleeding</a:t>
            </a:r>
            <a:endParaRPr sz="1800"/>
          </a:p>
          <a:p>
            <a:pPr marL="2743200" marR="0" lvl="3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sz="1800"/>
              <a:t>Loss of a thrill after pressure is applied</a:t>
            </a:r>
            <a:endParaRPr sz="180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23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ferences</a:t>
            </a:r>
            <a:endParaRPr/>
          </a:p>
        </p:txBody>
      </p:sp>
      <p:sp>
        <p:nvSpPr>
          <p:cNvPr id="143" name="Google Shape;143;p23"/>
          <p:cNvSpPr txBox="1"/>
          <p:nvPr/>
        </p:nvSpPr>
        <p:spPr>
          <a:xfrm>
            <a:off x="453250" y="1162700"/>
            <a:ext cx="8355600" cy="358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Andereck J. Bleeding Dialysis Fistula. In: Whitney J, Nordt S, Mattu A, Swadron S, eds. CorePendium. Burbank, CA: CorePendium, LLC. Updated January 11, 2023. Accessed February 2, 2024. 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ww.emrap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orependium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chapter/recR2O3lFsfRnXeR9/Bleeding-Dialysis-Fistula#h.hspeqetuar2t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alvert J, Cline DM. End-Stage Renal Disease. In: Tintinalli JE, Ma O, Yealy DM, Meckler GD, Stapczynski J, Cline DM, Thomas SH. eds. </a:t>
            </a:r>
            <a:r>
              <a:rPr lang="en" sz="1000" i="1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Tintinalli's Emergency Medicine: A Comprehensive Study Guide, 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9</a:t>
            </a:r>
            <a:r>
              <a:rPr lang="en" sz="1000" baseline="30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th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 ed. McGraw-Hill Education; 2020. Accessed February 02, 2024. 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accessemergencymedicine.mhmedical.com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ontent.aspx?bookid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=2353&amp;sectionid=219642947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Rosh Review. 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RoshReview.com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. November 2020. Accessed February 2, 2024. 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app.roshreview.com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subscribers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exams_questions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927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olfson A. Renal Failure. In: </a:t>
            </a:r>
            <a:r>
              <a:rPr lang="en" sz="1000" i="1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Rosen’s Emergency Medicine: Concepts and Clinical Practice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. 10th ed. Elsevier; 2023:1163-1180.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Suturing a bleeding dialysis fistula. EM:RAP.ORG. Accessed February 2, 2024.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ww.emrap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episode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suturinga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suturinga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Bleeding AV Shunt. EM:RAP.ORG. Accessed February 2, 2024. Published July 28, 2008. Accessed January 20, 2026.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ww.emrap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episode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ursideconsult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urbsideconsult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Radiocephalic Fistula. In: Wikimedia Commons. Accessed February 17, 2026.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commons.wikimedia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wiki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File:Radiocephalic_fistula.svg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Purse String Suture. In: Wikimedia Commons. Published February 28, 2014. Accessed January 20, 2026.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upload.wikimedia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ikipedia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commons/1/18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Purse_string_suture.sv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 </a:t>
            </a:r>
            <a:endParaRPr sz="1000" dirty="0">
              <a:solidFill>
                <a:schemeClr val="dk2"/>
              </a:solidFill>
              <a:highlight>
                <a:srgbClr val="FFFFFF"/>
              </a:highlight>
              <a:latin typeface="Lato"/>
              <a:ea typeface="Lato"/>
              <a:cs typeface="Lato"/>
              <a:sym typeface="Lato"/>
            </a:endParaRPr>
          </a:p>
          <a:p>
            <a:pPr marL="457200" lvl="0" indent="-292100">
              <a:lnSpc>
                <a:spcPct val="115000"/>
              </a:lnSpc>
              <a:buClr>
                <a:schemeClr val="dk2"/>
              </a:buClr>
              <a:buSzPts val="1000"/>
              <a:buFont typeface="Lato"/>
              <a:buChar char="●"/>
            </a:pP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Vascular Closure Device. In: Wikimedia Commons. Published May 6, 2023. Accessed January 20, 2026. https:/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upload.wikimedia.org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wikipedia</a:t>
            </a:r>
            <a:r>
              <a:rPr lang="en" sz="1000" dirty="0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/commons/e/e2/</a:t>
            </a:r>
            <a:r>
              <a:rPr lang="en" sz="1000" dirty="0" err="1">
                <a:solidFill>
                  <a:schemeClr val="dk2"/>
                </a:solidFill>
                <a:highlight>
                  <a:srgbClr val="FFFFFF"/>
                </a:highlight>
                <a:latin typeface="Lato"/>
                <a:ea typeface="Lato"/>
                <a:cs typeface="Lato"/>
                <a:sym typeface="Lato"/>
              </a:rPr>
              <a:t>Vascular_closure_device.jpg</a:t>
            </a:r>
            <a:endParaRPr sz="1000" dirty="0">
              <a:solidFill>
                <a:schemeClr val="dk2"/>
              </a:solidFill>
              <a:latin typeface="Lato"/>
              <a:ea typeface="Lato"/>
              <a:cs typeface="Lato"/>
              <a:sym typeface="Lato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4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fferent Types of Dialysis Access</a:t>
            </a:r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body" idx="1"/>
          </p:nvPr>
        </p:nvSpPr>
        <p:spPr>
          <a:xfrm>
            <a:off x="28075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r>
              <a:rPr lang="en"/>
              <a:t>Fistula vs Graft</a:t>
            </a:r>
            <a:endParaRPr/>
          </a:p>
        </p:txBody>
      </p:sp>
      <p:pic>
        <p:nvPicPr>
          <p:cNvPr id="80" name="Google Shape;80;p14" descr="Diagram of blood vessels in a hand&#10;&#10;AI-generated content may be incorrect.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381813" y="1152475"/>
            <a:ext cx="2085769" cy="3553000"/>
          </a:xfrm>
          <a:prstGeom prst="rect">
            <a:avLst/>
          </a:prstGeom>
          <a:noFill/>
          <a:ln>
            <a:noFill/>
          </a:ln>
        </p:spPr>
      </p:pic>
      <p:sp>
        <p:nvSpPr>
          <p:cNvPr id="81" name="Google Shape;81;p14"/>
          <p:cNvSpPr/>
          <p:nvPr/>
        </p:nvSpPr>
        <p:spPr>
          <a:xfrm rot="10800000">
            <a:off x="4669151" y="3099077"/>
            <a:ext cx="208800" cy="208800"/>
          </a:xfrm>
          <a:prstGeom prst="blockArc">
            <a:avLst>
              <a:gd name="adj1" fmla="val 10800000"/>
              <a:gd name="adj2" fmla="val 0"/>
              <a:gd name="adj3" fmla="val 25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82" name="Google Shape;82;p14"/>
          <p:cNvCxnSpPr>
            <a:endCxn id="81" idx="0"/>
          </p:cNvCxnSpPr>
          <p:nvPr/>
        </p:nvCxnSpPr>
        <p:spPr>
          <a:xfrm rot="10800000">
            <a:off x="4851851" y="3203477"/>
            <a:ext cx="799500" cy="251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83" name="Google Shape;83;p14"/>
          <p:cNvSpPr txBox="1"/>
          <p:nvPr/>
        </p:nvSpPr>
        <p:spPr>
          <a:xfrm>
            <a:off x="5651350" y="3307875"/>
            <a:ext cx="858600" cy="20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2"/>
                </a:solidFill>
              </a:rPr>
              <a:t>graft</a:t>
            </a:r>
            <a:endParaRPr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5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lysis- Related Emergencies</a:t>
            </a:r>
            <a:endParaRPr/>
          </a:p>
        </p:txBody>
      </p:sp>
      <p:sp>
        <p:nvSpPr>
          <p:cNvPr id="90" name="Google Shape;90;p15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Hyperkalemia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Volume Overload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Bleed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Infection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neurysm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Pseudoaneurysm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16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lysis Access Hemorrhage</a:t>
            </a:r>
            <a:endParaRPr/>
          </a:p>
        </p:txBody>
      </p:sp>
      <p:sp>
        <p:nvSpPr>
          <p:cNvPr id="96" name="Google Shape;96;p16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~250 deaths/yr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Grafts have a greater risk than fistulas for complication including bleeding 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~6x relative risk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Worse with</a:t>
            </a:r>
            <a:endParaRPr/>
          </a:p>
          <a:p>
            <a: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Coagulopathy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Increased intraluminal pressure from proximal vein stenosis 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Infection at the site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Hypertension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Repeat trauma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17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tepwise Approach to Management of a Bleeding Fistula</a:t>
            </a:r>
            <a:endParaRPr/>
          </a:p>
        </p:txBody>
      </p:sp>
      <p:sp>
        <p:nvSpPr>
          <p:cNvPr id="102" name="Google Shape;102;p17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"/>
              <a:t>Direct pressure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"/>
              <a:t>Topical hemostatic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"/>
              <a:t>Sutur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"/>
              <a:t>Tourniquet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18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opical Hemostatic Agents</a:t>
            </a:r>
            <a:endParaRPr/>
          </a:p>
        </p:txBody>
      </p:sp>
      <p:sp>
        <p:nvSpPr>
          <p:cNvPr id="108" name="Google Shape;108;p18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marR="0" lvl="0" indent="-34290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Gelatin sponges</a:t>
            </a:r>
            <a:endParaRPr/>
          </a:p>
          <a:p>
            <a: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Microfibrillar collagen</a:t>
            </a:r>
            <a:endParaRPr/>
          </a:p>
          <a:p>
            <a: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Oxidized regenerated cellulose</a:t>
            </a:r>
            <a:endParaRPr/>
          </a:p>
          <a:p>
            <a: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Tranexamic acid solution–soaked gauze</a:t>
            </a:r>
            <a:endParaRPr/>
          </a:p>
          <a:p>
            <a: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Topical thrombin either on gauze or on prothrombotic matrix</a:t>
            </a:r>
            <a:endParaRPr/>
          </a:p>
          <a:p>
            <a: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Chitosan</a:t>
            </a:r>
            <a:endParaRPr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Google Shape;113;p19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Needle Types</a:t>
            </a:r>
            <a:endParaRPr/>
          </a:p>
        </p:txBody>
      </p:sp>
      <p:pic>
        <p:nvPicPr>
          <p:cNvPr id="114" name="Google Shape;114;p19" title="Needle Types.jpg"/>
          <p:cNvPicPr preferRelativeResize="0"/>
          <p:nvPr/>
        </p:nvPicPr>
        <p:blipFill rotWithShape="1">
          <a:blip r:embed="rId3">
            <a:alphaModFix/>
          </a:blip>
          <a:srcRect b="11824"/>
          <a:stretch/>
        </p:blipFill>
        <p:spPr>
          <a:xfrm>
            <a:off x="3473000" y="1127275"/>
            <a:ext cx="2645974" cy="3568425"/>
          </a:xfrm>
          <a:prstGeom prst="rect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20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uture Types</a:t>
            </a:r>
            <a:endParaRPr/>
          </a:p>
        </p:txBody>
      </p:sp>
      <p:pic>
        <p:nvPicPr>
          <p:cNvPr id="120" name="Google Shape;120;p20" descr="A drawing of a cut and cut line&#10;&#10;AI-generated content may be incorrect.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11700" y="2002300"/>
            <a:ext cx="2729775" cy="1716750"/>
          </a:xfrm>
          <a:prstGeom prst="rect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121" name="Google Shape;121;p20" descr="A blue circle with black lines&#10;&#10;AI-generated content may be incorrect.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296013" y="1408475"/>
            <a:ext cx="2668900" cy="3245950"/>
          </a:xfrm>
          <a:prstGeom prst="rect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122" name="Google Shape;122;p20" descr="A person's hand with a blood sample on it&#10;&#10;AI-generated content may be incorrect.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479000" y="1468287"/>
            <a:ext cx="2353300" cy="3126329"/>
          </a:xfrm>
          <a:prstGeom prst="rect">
            <a:avLst/>
          </a:prstGeom>
          <a:noFill/>
          <a:ln>
            <a:noFill/>
          </a:ln>
        </p:spPr>
      </p:pic>
      <p:sp>
        <p:nvSpPr>
          <p:cNvPr id="123" name="Google Shape;123;p20"/>
          <p:cNvSpPr txBox="1"/>
          <p:nvPr/>
        </p:nvSpPr>
        <p:spPr>
          <a:xfrm>
            <a:off x="3738000" y="1041575"/>
            <a:ext cx="1668000" cy="30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Purse string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124" name="Google Shape;124;p20"/>
          <p:cNvSpPr txBox="1"/>
          <p:nvPr/>
        </p:nvSpPr>
        <p:spPr>
          <a:xfrm>
            <a:off x="1015685" y="1528875"/>
            <a:ext cx="1321800" cy="30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Figure of 8</a:t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125" name="Google Shape;125;p20"/>
          <p:cNvSpPr txBox="1"/>
          <p:nvPr/>
        </p:nvSpPr>
        <p:spPr>
          <a:xfrm>
            <a:off x="6668495" y="983975"/>
            <a:ext cx="1974300" cy="42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2"/>
                </a:solidFill>
              </a:rPr>
              <a:t>Vascular Closure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21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Additional Considerations</a:t>
            </a:r>
            <a:endParaRPr/>
          </a:p>
        </p:txBody>
      </p:sp>
      <p:sp>
        <p:nvSpPr>
          <p:cNvPr id="131" name="Google Shape;131;p21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nticoagulant reversal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Desmopressin for uremia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Protamine if heparin used during dialysis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wiss">
  <a:themeElements>
    <a:clrScheme name="Swiss">
      <a:dk1>
        <a:srgbClr val="F46524"/>
      </a:dk1>
      <a:lt1>
        <a:srgbClr val="FFFFFF"/>
      </a:lt1>
      <a:dk2>
        <a:srgbClr val="000000"/>
      </a:dk2>
      <a:lt2>
        <a:srgbClr val="757575"/>
      </a:lt2>
      <a:accent1>
        <a:srgbClr val="01579B"/>
      </a:accent1>
      <a:accent2>
        <a:srgbClr val="27C7BD"/>
      </a:accent2>
      <a:accent3>
        <a:srgbClr val="0099E8"/>
      </a:accent3>
      <a:accent4>
        <a:srgbClr val="51B9A3"/>
      </a:accent4>
      <a:accent5>
        <a:srgbClr val="FB8C00"/>
      </a:accent5>
      <a:accent6>
        <a:srgbClr val="FFAE88"/>
      </a:accent6>
      <a:hlink>
        <a:srgbClr val="0277BD"/>
      </a:hlink>
      <a:folHlink>
        <a:srgbClr val="0277B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179</Words>
  <Application>Microsoft Macintosh PowerPoint</Application>
  <PresentationFormat>On-screen Show (16:9)</PresentationFormat>
  <Paragraphs>134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Lato</vt:lpstr>
      <vt:lpstr>Raleway</vt:lpstr>
      <vt:lpstr>Arial</vt:lpstr>
      <vt:lpstr>Swiss</vt:lpstr>
      <vt:lpstr>Dialysis Access Emergencies</vt:lpstr>
      <vt:lpstr>Different Types of Dialysis Access</vt:lpstr>
      <vt:lpstr>Dialysis- Related Emergencies</vt:lpstr>
      <vt:lpstr>Dialysis Access Hemorrhage</vt:lpstr>
      <vt:lpstr>Stepwise Approach to Management of a Bleeding Fistula</vt:lpstr>
      <vt:lpstr>Topical Hemostatic Agents</vt:lpstr>
      <vt:lpstr>Needle Types</vt:lpstr>
      <vt:lpstr>Suture Types</vt:lpstr>
      <vt:lpstr>Additional Considerations</vt:lpstr>
      <vt:lpstr>When to consult a specialist?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Wray, Alisa</cp:lastModifiedBy>
  <cp:revision>4</cp:revision>
  <dcterms:modified xsi:type="dcterms:W3CDTF">2026-04-19T01:38:17Z</dcterms:modified>
</cp:coreProperties>
</file>